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584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891A11-FEB9-4854-8487-DCBA55B45892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" name="Rectangle 7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6D913B-49DD-422B-B0F6-4EB564F315F7}" type="slidenum"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ImmunoRun 13 / Thau PreImmune / c5 blk 15 area1.01, 1.05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874C5A-7693-4A63-B528-3D7E715F1C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0820E8-E186-40C2-90DA-1108631A09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E77587-1939-499D-86C5-085BAC28E54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BE4D90-8B84-47D4-8EE6-26B17BBE83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FA2B61-565A-40FE-AC51-ED4A43A931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DAEB14-C9AE-4EAE-850A-2EB54BC0A2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961FE4-8032-43A0-9C79-5A71A48EA2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9ABC25-4F2D-489F-ACC8-897594F99D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6010D6-1917-41DB-989B-B831B53C88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DF90A9-C46E-49D1-93CC-A74898E4B2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F91B9D-50B0-4210-AB83-22C7088017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71A77D-82F1-445D-A4F6-267EE43C48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E6B2CB-0CC5-4701-991A-3064BA8453D5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11"/>
          <p:cNvGrpSpPr/>
          <p:nvPr/>
        </p:nvGrpSpPr>
        <p:grpSpPr>
          <a:xfrm>
            <a:off x="1638360" y="4343400"/>
            <a:ext cx="3581280" cy="3730680"/>
            <a:chOff x="1638360" y="4343400"/>
            <a:chExt cx="3581280" cy="3730680"/>
          </a:xfrm>
        </p:grpSpPr>
        <p:pic>
          <p:nvPicPr>
            <p:cNvPr id="49" name="Picture 10" descr=""/>
            <p:cNvPicPr/>
            <p:nvPr/>
          </p:nvPicPr>
          <p:blipFill>
            <a:blip r:embed="rId1"/>
            <a:stretch/>
          </p:blipFill>
          <p:spPr>
            <a:xfrm>
              <a:off x="1638360" y="4343400"/>
              <a:ext cx="3581280" cy="3730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Line 9"/>
            <p:cNvSpPr/>
            <p:nvPr/>
          </p:nvSpPr>
          <p:spPr>
            <a:xfrm>
              <a:off x="4332600" y="7898040"/>
              <a:ext cx="3409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51" name="Group 13"/>
          <p:cNvGrpSpPr/>
          <p:nvPr/>
        </p:nvGrpSpPr>
        <p:grpSpPr>
          <a:xfrm>
            <a:off x="1638360" y="457200"/>
            <a:ext cx="3581280" cy="3809880"/>
            <a:chOff x="1638360" y="457200"/>
            <a:chExt cx="3581280" cy="3809880"/>
          </a:xfrm>
        </p:grpSpPr>
        <p:pic>
          <p:nvPicPr>
            <p:cNvPr id="52" name="Picture 6" descr=""/>
            <p:cNvPicPr/>
            <p:nvPr/>
          </p:nvPicPr>
          <p:blipFill>
            <a:blip r:embed="rId2"/>
            <a:stretch/>
          </p:blipFill>
          <p:spPr>
            <a:xfrm>
              <a:off x="1638360" y="457200"/>
              <a:ext cx="3581280" cy="3809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Line 12"/>
            <p:cNvSpPr/>
            <p:nvPr/>
          </p:nvSpPr>
          <p:spPr>
            <a:xfrm>
              <a:off x="1993320" y="4056120"/>
              <a:ext cx="425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54" name="Text Box 10"/>
          <p:cNvSpPr/>
          <p:nvPr/>
        </p:nvSpPr>
        <p:spPr>
          <a:xfrm>
            <a:off x="685800" y="8169120"/>
            <a:ext cx="54864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dditional file 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. Preimmune serum controls for immunogold labeling of sieve element.  A) Low magnification image of sieve element with starch granules and sieve plate. Scale bar = 2µm. The arrow marks the region enlarged in lower panel. B), High magnification image of portion of sieve element. Scale bar =  500nm.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Text Box 17"/>
          <p:cNvSpPr/>
          <p:nvPr/>
        </p:nvSpPr>
        <p:spPr>
          <a:xfrm>
            <a:off x="1221120" y="38088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Text Box 18"/>
          <p:cNvSpPr/>
          <p:nvPr/>
        </p:nvSpPr>
        <p:spPr>
          <a:xfrm>
            <a:off x="1221120" y="4267080"/>
            <a:ext cx="3834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Line 19"/>
          <p:cNvSpPr/>
          <p:nvPr/>
        </p:nvSpPr>
        <p:spPr>
          <a:xfrm flipH="1">
            <a:off x="3581280" y="1371600"/>
            <a:ext cx="152640" cy="152280"/>
          </a:xfrm>
          <a:prstGeom prst="line">
            <a:avLst/>
          </a:prstGeom>
          <a:ln w="19080">
            <a:solidFill>
              <a:srgbClr val="000000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8-23T17:10:22Z</dcterms:created>
  <dc:creator>Peter Constabel</dc:creator>
  <dc:description/>
  <dc:language>en-US</dc:language>
  <cp:lastModifiedBy>peterconstabel Constabel</cp:lastModifiedBy>
  <dcterms:modified xsi:type="dcterms:W3CDTF">2010-08-23T17:42:19Z</dcterms:modified>
  <cp:revision>13</cp:revision>
  <dc:subject/>
  <dc:title>PowerPoint Presentation</dc:title>
</cp:coreProperties>
</file>